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0" r:id="rId2"/>
    <p:sldId id="1009" r:id="rId3"/>
    <p:sldId id="1010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>
        <p:scale>
          <a:sx n="110" d="100"/>
          <a:sy n="110" d="100"/>
        </p:scale>
        <p:origin x="1176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ytotsuka/Desktop/&#20840;&#12465;&#12441;&#12494;&#12512;&#22793;&#30064;&#35299;&#26512;&#65288;&#12495;&#12441;&#12463;&#12486;&#12522;&#12450;&#65289;/NO-bile%20acids/YG7108;%20NO-gCA,%20NO-gDCA/YG7108_NO-gDCA(180605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ytotsuka/Desktop/&#20840;&#12465;&#12441;&#12494;&#12512;&#22793;&#30064;&#35299;&#26512;&#65288;&#12495;&#12441;&#12463;&#12486;&#12522;&#12450;&#65289;/NO-bile%20acids/TA100_NO-bile%20acid(TA1535)/NMF_Bacteria_Res%20(NitrosoBile%20Acids)/NGS-bile%20acid_strand_info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dmin/Documents/Totsuka_Data/Bacteria/Signatur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b="1" i="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b="1" i="0" dirty="0">
                <a:latin typeface="Arial" panose="020B0604020202020204" pitchFamily="34" charset="0"/>
                <a:cs typeface="Arial" panose="020B0604020202020204" pitchFamily="34" charset="0"/>
              </a:rPr>
              <a:t>YG7108</a:t>
            </a:r>
            <a:r>
              <a:rPr lang="ja-JP" altLang="en-US" b="1" i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b="1" i="0" dirty="0">
                <a:latin typeface="Arial" panose="020B0604020202020204" pitchFamily="34" charset="0"/>
                <a:cs typeface="Arial" panose="020B0604020202020204" pitchFamily="34" charset="0"/>
              </a:rPr>
              <a:t>NO-GDCA</a:t>
            </a:r>
            <a:endParaRPr lang="ja-JP" altLang="en-US" b="1" i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7.656533975750443E-2"/>
          <c:y val="0.16966112685061394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集計１ (2)'!$P$4</c:f>
              <c:strCache>
                <c:ptCount val="1"/>
                <c:pt idx="0">
                  <c:v>AA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4:$V$4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1.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53-7944-AB56-659B9D77D43F}"/>
            </c:ext>
          </c:extLst>
        </c:ser>
        <c:ser>
          <c:idx val="1"/>
          <c:order val="1"/>
          <c:tx>
            <c:strRef>
              <c:f>'集計１ (2)'!$P$5</c:f>
              <c:strCache>
                <c:ptCount val="1"/>
                <c:pt idx="0">
                  <c:v>AC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5:$V$5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12.8</c:v>
                </c:pt>
                <c:pt idx="3">
                  <c:v>0</c:v>
                </c:pt>
                <c:pt idx="4">
                  <c:v>0.2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553-7944-AB56-659B9D77D43F}"/>
            </c:ext>
          </c:extLst>
        </c:ser>
        <c:ser>
          <c:idx val="2"/>
          <c:order val="2"/>
          <c:tx>
            <c:strRef>
              <c:f>'集計１ (2)'!$P$6</c:f>
              <c:strCache>
                <c:ptCount val="1"/>
                <c:pt idx="0">
                  <c:v>AG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6:$V$6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3.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553-7944-AB56-659B9D77D43F}"/>
            </c:ext>
          </c:extLst>
        </c:ser>
        <c:ser>
          <c:idx val="3"/>
          <c:order val="3"/>
          <c:tx>
            <c:strRef>
              <c:f>'集計１ (2)'!$P$7</c:f>
              <c:strCache>
                <c:ptCount val="1"/>
                <c:pt idx="0">
                  <c:v>AT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7:$V$7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2.8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553-7944-AB56-659B9D77D43F}"/>
            </c:ext>
          </c:extLst>
        </c:ser>
        <c:ser>
          <c:idx val="4"/>
          <c:order val="4"/>
          <c:tx>
            <c:strRef>
              <c:f>'集計１ (2)'!$P$8</c:f>
              <c:strCache>
                <c:ptCount val="1"/>
                <c:pt idx="0">
                  <c:v>CA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8:$V$8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1.7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553-7944-AB56-659B9D77D43F}"/>
            </c:ext>
          </c:extLst>
        </c:ser>
        <c:ser>
          <c:idx val="5"/>
          <c:order val="5"/>
          <c:tx>
            <c:strRef>
              <c:f>'集計１ (2)'!$P$9</c:f>
              <c:strCache>
                <c:ptCount val="1"/>
                <c:pt idx="0">
                  <c:v>CC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9:$V$9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8.3000000000000007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553-7944-AB56-659B9D77D43F}"/>
            </c:ext>
          </c:extLst>
        </c:ser>
        <c:ser>
          <c:idx val="6"/>
          <c:order val="6"/>
          <c:tx>
            <c:strRef>
              <c:f>'集計１ (2)'!$P$10</c:f>
              <c:strCache>
                <c:ptCount val="1"/>
                <c:pt idx="0">
                  <c:v>CG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10:$V$10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3.8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553-7944-AB56-659B9D77D43F}"/>
            </c:ext>
          </c:extLst>
        </c:ser>
        <c:ser>
          <c:idx val="7"/>
          <c:order val="7"/>
          <c:tx>
            <c:strRef>
              <c:f>'集計１ (2)'!$P$11</c:f>
              <c:strCache>
                <c:ptCount val="1"/>
                <c:pt idx="0">
                  <c:v>CT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11:$V$11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2.5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553-7944-AB56-659B9D77D43F}"/>
            </c:ext>
          </c:extLst>
        </c:ser>
        <c:ser>
          <c:idx val="8"/>
          <c:order val="8"/>
          <c:tx>
            <c:strRef>
              <c:f>'集計１ (2)'!$P$12</c:f>
              <c:strCache>
                <c:ptCount val="1"/>
                <c:pt idx="0">
                  <c:v>GA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12:$V$12</c:f>
              <c:numCache>
                <c:formatCode>General</c:formatCode>
                <c:ptCount val="6"/>
                <c:pt idx="0">
                  <c:v>0.2</c:v>
                </c:pt>
                <c:pt idx="1">
                  <c:v>0</c:v>
                </c:pt>
                <c:pt idx="2">
                  <c:v>3.2</c:v>
                </c:pt>
                <c:pt idx="3">
                  <c:v>0</c:v>
                </c:pt>
                <c:pt idx="4">
                  <c:v>0.2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553-7944-AB56-659B9D77D43F}"/>
            </c:ext>
          </c:extLst>
        </c:ser>
        <c:ser>
          <c:idx val="9"/>
          <c:order val="9"/>
          <c:tx>
            <c:strRef>
              <c:f>'集計１ (2)'!$P$13</c:f>
              <c:strCache>
                <c:ptCount val="1"/>
                <c:pt idx="0">
                  <c:v>GC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13:$V$13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19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553-7944-AB56-659B9D77D43F}"/>
            </c:ext>
          </c:extLst>
        </c:ser>
        <c:ser>
          <c:idx val="10"/>
          <c:order val="10"/>
          <c:tx>
            <c:strRef>
              <c:f>'集計１ (2)'!$P$14</c:f>
              <c:strCache>
                <c:ptCount val="1"/>
                <c:pt idx="0">
                  <c:v>GG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14:$V$14</c:f>
              <c:numCache>
                <c:formatCode>General</c:formatCode>
                <c:ptCount val="6"/>
                <c:pt idx="0">
                  <c:v>0.2</c:v>
                </c:pt>
                <c:pt idx="1">
                  <c:v>0</c:v>
                </c:pt>
                <c:pt idx="2">
                  <c:v>8.6999999999999993</c:v>
                </c:pt>
                <c:pt idx="3">
                  <c:v>0</c:v>
                </c:pt>
                <c:pt idx="4">
                  <c:v>0.4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553-7944-AB56-659B9D77D43F}"/>
            </c:ext>
          </c:extLst>
        </c:ser>
        <c:ser>
          <c:idx val="11"/>
          <c:order val="11"/>
          <c:tx>
            <c:strRef>
              <c:f>'集計１ (2)'!$P$15</c:f>
              <c:strCache>
                <c:ptCount val="1"/>
                <c:pt idx="0">
                  <c:v>GT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15:$V$15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10</c:v>
                </c:pt>
                <c:pt idx="3">
                  <c:v>0</c:v>
                </c:pt>
                <c:pt idx="4">
                  <c:v>0.2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0553-7944-AB56-659B9D77D43F}"/>
            </c:ext>
          </c:extLst>
        </c:ser>
        <c:ser>
          <c:idx val="12"/>
          <c:order val="12"/>
          <c:tx>
            <c:strRef>
              <c:f>'集計１ (2)'!$P$16</c:f>
              <c:strCache>
                <c:ptCount val="1"/>
                <c:pt idx="0">
                  <c:v>TA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16:$V$16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1.7</c:v>
                </c:pt>
                <c:pt idx="3">
                  <c:v>0</c:v>
                </c:pt>
                <c:pt idx="4">
                  <c:v>0.4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0553-7944-AB56-659B9D77D43F}"/>
            </c:ext>
          </c:extLst>
        </c:ser>
        <c:ser>
          <c:idx val="13"/>
          <c:order val="13"/>
          <c:tx>
            <c:strRef>
              <c:f>'集計１ (2)'!$P$17</c:f>
              <c:strCache>
                <c:ptCount val="1"/>
                <c:pt idx="0">
                  <c:v>TC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17:$V$17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10.7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0553-7944-AB56-659B9D77D43F}"/>
            </c:ext>
          </c:extLst>
        </c:ser>
        <c:ser>
          <c:idx val="14"/>
          <c:order val="14"/>
          <c:tx>
            <c:strRef>
              <c:f>'集計１ (2)'!$P$18</c:f>
              <c:strCache>
                <c:ptCount val="1"/>
                <c:pt idx="0">
                  <c:v>TG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18:$V$18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0553-7944-AB56-659B9D77D43F}"/>
            </c:ext>
          </c:extLst>
        </c:ser>
        <c:ser>
          <c:idx val="15"/>
          <c:order val="15"/>
          <c:tx>
            <c:strRef>
              <c:f>'集計１ (2)'!$P$19</c:f>
              <c:strCache>
                <c:ptCount val="1"/>
                <c:pt idx="0">
                  <c:v>TT</c:v>
                </c:pt>
              </c:strCache>
            </c:strRef>
          </c:tx>
          <c:invertIfNegative val="0"/>
          <c:cat>
            <c:strRef>
              <c:f>'集計１ (2)'!$Q$3:$V$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Q$19:$V$19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5.6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0553-7944-AB56-659B9D77D4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6083776"/>
        <c:axId val="1726086736"/>
      </c:barChart>
      <c:catAx>
        <c:axId val="17260837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 b="1" i="0" baseline="0">
                <a:latin typeface="Arial" panose="020B0604020202020204" pitchFamily="34" charset="0"/>
              </a:defRPr>
            </a:pPr>
            <a:endParaRPr lang="ja-JP"/>
          </a:p>
        </c:txPr>
        <c:crossAx val="1726086736"/>
        <c:crosses val="autoZero"/>
        <c:auto val="1"/>
        <c:lblAlgn val="ctr"/>
        <c:lblOffset val="100"/>
        <c:noMultiLvlLbl val="0"/>
      </c:catAx>
      <c:valAx>
        <c:axId val="17260867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1" i="0" baseline="0">
                <a:latin typeface="Arial" panose="020B0604020202020204" pitchFamily="34" charset="0"/>
              </a:defRPr>
            </a:pPr>
            <a:endParaRPr lang="ja-JP"/>
          </a:p>
        </c:txPr>
        <c:crossAx val="1726083776"/>
        <c:crosses val="autoZero"/>
        <c:crossBetween val="between"/>
        <c:majorUnit val="5"/>
      </c:valAx>
    </c:plotArea>
    <c:legend>
      <c:legendPos val="b"/>
      <c:overlay val="0"/>
      <c:txPr>
        <a:bodyPr/>
        <a:lstStyle/>
        <a:p>
          <a:pPr>
            <a:defRPr sz="1400" b="1" i="0">
              <a:latin typeface="Arial" panose="020B0604020202020204" pitchFamily="34" charset="0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b="1" i="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b="1" i="0" dirty="0">
                <a:latin typeface="Arial" panose="020B0604020202020204" pitchFamily="34" charset="0"/>
                <a:cs typeface="Arial" panose="020B0604020202020204" pitchFamily="34" charset="0"/>
              </a:rPr>
              <a:t>TA1535</a:t>
            </a:r>
            <a:r>
              <a:rPr lang="en-US" altLang="ja-JP" b="1" i="0" baseline="0" dirty="0">
                <a:latin typeface="Arial" panose="020B0604020202020204" pitchFamily="34" charset="0"/>
                <a:cs typeface="Arial" panose="020B0604020202020204" pitchFamily="34" charset="0"/>
              </a:rPr>
              <a:t>   NO-GDCA</a:t>
            </a:r>
            <a:endParaRPr lang="ja-JP" altLang="en-US" b="1" i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6.3269216830355524E-2"/>
          <c:y val="0.2013718711206773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3.1367538944603819E-2"/>
          <c:y val="0.20875644275808808"/>
          <c:w val="0.95695975942705702"/>
          <c:h val="0.702463698167326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集計１ (2)'!$M$44</c:f>
              <c:strCache>
                <c:ptCount val="1"/>
                <c:pt idx="0">
                  <c:v>AA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44:$S$44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.7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3A-F744-8781-299E92C5A045}"/>
            </c:ext>
          </c:extLst>
        </c:ser>
        <c:ser>
          <c:idx val="1"/>
          <c:order val="1"/>
          <c:tx>
            <c:strRef>
              <c:f>'集計１ (2)'!$M$45</c:f>
              <c:strCache>
                <c:ptCount val="1"/>
                <c:pt idx="0">
                  <c:v>AC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45:$S$45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6.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03A-F744-8781-299E92C5A045}"/>
            </c:ext>
          </c:extLst>
        </c:ser>
        <c:ser>
          <c:idx val="2"/>
          <c:order val="2"/>
          <c:tx>
            <c:strRef>
              <c:f>'集計１ (2)'!$M$46</c:f>
              <c:strCache>
                <c:ptCount val="1"/>
                <c:pt idx="0">
                  <c:v>AG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46:$S$46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3.6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03A-F744-8781-299E92C5A045}"/>
            </c:ext>
          </c:extLst>
        </c:ser>
        <c:ser>
          <c:idx val="3"/>
          <c:order val="3"/>
          <c:tx>
            <c:strRef>
              <c:f>'集計１ (2)'!$M$47</c:f>
              <c:strCache>
                <c:ptCount val="1"/>
                <c:pt idx="0">
                  <c:v>AT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47:$S$47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6.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03A-F744-8781-299E92C5A045}"/>
            </c:ext>
          </c:extLst>
        </c:ser>
        <c:ser>
          <c:idx val="4"/>
          <c:order val="4"/>
          <c:tx>
            <c:strRef>
              <c:f>'集計１ (2)'!$M$48</c:f>
              <c:strCache>
                <c:ptCount val="1"/>
                <c:pt idx="0">
                  <c:v>CA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48:$S$48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1.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03A-F744-8781-299E92C5A045}"/>
            </c:ext>
          </c:extLst>
        </c:ser>
        <c:ser>
          <c:idx val="5"/>
          <c:order val="5"/>
          <c:tx>
            <c:strRef>
              <c:f>'集計１ (2)'!$M$49</c:f>
              <c:strCache>
                <c:ptCount val="1"/>
                <c:pt idx="0">
                  <c:v>CC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49:$S$49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8.6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03A-F744-8781-299E92C5A045}"/>
            </c:ext>
          </c:extLst>
        </c:ser>
        <c:ser>
          <c:idx val="6"/>
          <c:order val="6"/>
          <c:tx>
            <c:strRef>
              <c:f>'集計１ (2)'!$M$50</c:f>
              <c:strCache>
                <c:ptCount val="1"/>
                <c:pt idx="0">
                  <c:v>CG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50:$S$50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4.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03A-F744-8781-299E92C5A045}"/>
            </c:ext>
          </c:extLst>
        </c:ser>
        <c:ser>
          <c:idx val="7"/>
          <c:order val="7"/>
          <c:tx>
            <c:strRef>
              <c:f>'集計１ (2)'!$M$51</c:f>
              <c:strCache>
                <c:ptCount val="1"/>
                <c:pt idx="0">
                  <c:v>CT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51:$S$51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7.9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303A-F744-8781-299E92C5A045}"/>
            </c:ext>
          </c:extLst>
        </c:ser>
        <c:ser>
          <c:idx val="8"/>
          <c:order val="8"/>
          <c:tx>
            <c:strRef>
              <c:f>'集計１ (2)'!$M$52</c:f>
              <c:strCache>
                <c:ptCount val="1"/>
                <c:pt idx="0">
                  <c:v>GA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52:$S$52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1.4</c:v>
                </c:pt>
                <c:pt idx="3">
                  <c:v>0.7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03A-F744-8781-299E92C5A045}"/>
            </c:ext>
          </c:extLst>
        </c:ser>
        <c:ser>
          <c:idx val="9"/>
          <c:order val="9"/>
          <c:tx>
            <c:strRef>
              <c:f>'集計１ (2)'!$M$53</c:f>
              <c:strCache>
                <c:ptCount val="1"/>
                <c:pt idx="0">
                  <c:v>GC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53:$S$53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2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303A-F744-8781-299E92C5A045}"/>
            </c:ext>
          </c:extLst>
        </c:ser>
        <c:ser>
          <c:idx val="10"/>
          <c:order val="10"/>
          <c:tx>
            <c:strRef>
              <c:f>'集計１ (2)'!$M$54</c:f>
              <c:strCache>
                <c:ptCount val="1"/>
                <c:pt idx="0">
                  <c:v>GG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54:$S$54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5.7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303A-F744-8781-299E92C5A045}"/>
            </c:ext>
          </c:extLst>
        </c:ser>
        <c:ser>
          <c:idx val="11"/>
          <c:order val="11"/>
          <c:tx>
            <c:strRef>
              <c:f>'集計１ (2)'!$M$55</c:f>
              <c:strCache>
                <c:ptCount val="1"/>
                <c:pt idx="0">
                  <c:v>GT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55:$S$55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15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303A-F744-8781-299E92C5A045}"/>
            </c:ext>
          </c:extLst>
        </c:ser>
        <c:ser>
          <c:idx val="12"/>
          <c:order val="12"/>
          <c:tx>
            <c:strRef>
              <c:f>'集計１ (2)'!$M$56</c:f>
              <c:strCache>
                <c:ptCount val="1"/>
                <c:pt idx="0">
                  <c:v>TA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56:$S$56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3.6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303A-F744-8781-299E92C5A045}"/>
            </c:ext>
          </c:extLst>
        </c:ser>
        <c:ser>
          <c:idx val="13"/>
          <c:order val="13"/>
          <c:tx>
            <c:strRef>
              <c:f>'集計１ (2)'!$M$57</c:f>
              <c:strCache>
                <c:ptCount val="1"/>
                <c:pt idx="0">
                  <c:v>TC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57:$S$57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5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303A-F744-8781-299E92C5A045}"/>
            </c:ext>
          </c:extLst>
        </c:ser>
        <c:ser>
          <c:idx val="14"/>
          <c:order val="14"/>
          <c:tx>
            <c:strRef>
              <c:f>'集計１ (2)'!$M$58</c:f>
              <c:strCache>
                <c:ptCount val="1"/>
                <c:pt idx="0">
                  <c:v>TG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58:$S$58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1.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303A-F744-8781-299E92C5A045}"/>
            </c:ext>
          </c:extLst>
        </c:ser>
        <c:ser>
          <c:idx val="15"/>
          <c:order val="15"/>
          <c:tx>
            <c:strRef>
              <c:f>'集計１ (2)'!$M$59</c:f>
              <c:strCache>
                <c:ptCount val="1"/>
                <c:pt idx="0">
                  <c:v>TT</c:v>
                </c:pt>
              </c:strCache>
            </c:strRef>
          </c:tx>
          <c:invertIfNegative val="0"/>
          <c:cat>
            <c:strRef>
              <c:f>'集計１ (2)'!$N$43:$S$43</c:f>
              <c:strCache>
                <c:ptCount val="6"/>
                <c:pt idx="0">
                  <c:v>C→A</c:v>
                </c:pt>
                <c:pt idx="1">
                  <c:v>C→G</c:v>
                </c:pt>
                <c:pt idx="2">
                  <c:v>C→T</c:v>
                </c:pt>
                <c:pt idx="3">
                  <c:v>T→A</c:v>
                </c:pt>
                <c:pt idx="4">
                  <c:v>T→C</c:v>
                </c:pt>
                <c:pt idx="5">
                  <c:v>T→G</c:v>
                </c:pt>
              </c:strCache>
            </c:strRef>
          </c:cat>
          <c:val>
            <c:numRef>
              <c:f>'集計１ (2)'!$N$59:$S$59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7.1</c:v>
                </c:pt>
                <c:pt idx="3">
                  <c:v>0.7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303A-F744-8781-299E92C5A0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973654992"/>
        <c:axId val="-1973652032"/>
      </c:barChart>
      <c:catAx>
        <c:axId val="-19736549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 b="1" i="0" baseline="0">
                <a:latin typeface="Arial" panose="020B0604020202020204" pitchFamily="34" charset="0"/>
              </a:defRPr>
            </a:pPr>
            <a:endParaRPr lang="ja-JP"/>
          </a:p>
        </c:txPr>
        <c:crossAx val="-1973652032"/>
        <c:crosses val="autoZero"/>
        <c:auto val="1"/>
        <c:lblAlgn val="ctr"/>
        <c:lblOffset val="100"/>
        <c:noMultiLvlLbl val="0"/>
      </c:catAx>
      <c:valAx>
        <c:axId val="-19736520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1" i="0" baseline="0">
                <a:latin typeface="Arial" panose="020B0604020202020204" pitchFamily="34" charset="0"/>
              </a:defRPr>
            </a:pPr>
            <a:endParaRPr lang="ja-JP"/>
          </a:p>
        </c:txPr>
        <c:crossAx val="-19736549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Exposures!$A$3</c:f>
              <c:strCache>
                <c:ptCount val="1"/>
                <c:pt idx="0">
                  <c:v>Sig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Exposures!$B$2:$AI$2</c:f>
              <c:strCache>
                <c:ptCount val="34"/>
                <c:pt idx="0">
                  <c:v>A-10</c:v>
                </c:pt>
                <c:pt idx="1">
                  <c:v>A-1</c:v>
                </c:pt>
                <c:pt idx="2">
                  <c:v>A-2</c:v>
                </c:pt>
                <c:pt idx="3">
                  <c:v>A-3</c:v>
                </c:pt>
                <c:pt idx="4">
                  <c:v>A-4</c:v>
                </c:pt>
                <c:pt idx="5">
                  <c:v>A-5</c:v>
                </c:pt>
                <c:pt idx="6">
                  <c:v>A-7</c:v>
                </c:pt>
                <c:pt idx="7">
                  <c:v>A-9</c:v>
                </c:pt>
                <c:pt idx="8">
                  <c:v>B-1</c:v>
                </c:pt>
                <c:pt idx="9">
                  <c:v>B-2</c:v>
                </c:pt>
                <c:pt idx="10">
                  <c:v>B-3</c:v>
                </c:pt>
                <c:pt idx="11">
                  <c:v>B-4</c:v>
                </c:pt>
                <c:pt idx="12">
                  <c:v>B-5</c:v>
                </c:pt>
                <c:pt idx="13">
                  <c:v>B-6</c:v>
                </c:pt>
                <c:pt idx="14">
                  <c:v>B-7</c:v>
                </c:pt>
                <c:pt idx="15">
                  <c:v>C-10</c:v>
                </c:pt>
                <c:pt idx="16">
                  <c:v>C-1</c:v>
                </c:pt>
                <c:pt idx="17">
                  <c:v>C-2</c:v>
                </c:pt>
                <c:pt idx="18">
                  <c:v>C-3</c:v>
                </c:pt>
                <c:pt idx="19">
                  <c:v>C-4</c:v>
                </c:pt>
                <c:pt idx="20">
                  <c:v>C-5</c:v>
                </c:pt>
                <c:pt idx="21">
                  <c:v>C-6</c:v>
                </c:pt>
                <c:pt idx="22">
                  <c:v>C-7</c:v>
                </c:pt>
                <c:pt idx="23">
                  <c:v>C-8</c:v>
                </c:pt>
                <c:pt idx="24">
                  <c:v>C-9</c:v>
                </c:pt>
                <c:pt idx="25">
                  <c:v>D-10</c:v>
                </c:pt>
                <c:pt idx="26">
                  <c:v>D-1</c:v>
                </c:pt>
                <c:pt idx="27">
                  <c:v>D-2</c:v>
                </c:pt>
                <c:pt idx="28">
                  <c:v>D-3</c:v>
                </c:pt>
                <c:pt idx="29">
                  <c:v>D-4</c:v>
                </c:pt>
                <c:pt idx="30">
                  <c:v>D-5</c:v>
                </c:pt>
                <c:pt idx="31">
                  <c:v>D-7</c:v>
                </c:pt>
                <c:pt idx="32">
                  <c:v>D-8</c:v>
                </c:pt>
                <c:pt idx="33">
                  <c:v>D-9</c:v>
                </c:pt>
              </c:strCache>
            </c:strRef>
          </c:cat>
          <c:val>
            <c:numRef>
              <c:f>Exposures!$B$3:$AI$3</c:f>
              <c:numCache>
                <c:formatCode>0.00E+00</c:formatCode>
                <c:ptCount val="34"/>
                <c:pt idx="0">
                  <c:v>50.6</c:v>
                </c:pt>
                <c:pt idx="1">
                  <c:v>4.8899999999999997</c:v>
                </c:pt>
                <c:pt idx="2">
                  <c:v>72.400000000000006</c:v>
                </c:pt>
                <c:pt idx="3">
                  <c:v>7.1599999999999966</c:v>
                </c:pt>
                <c:pt idx="4">
                  <c:v>15.3</c:v>
                </c:pt>
                <c:pt idx="5">
                  <c:v>22.2</c:v>
                </c:pt>
                <c:pt idx="6">
                  <c:v>36.6</c:v>
                </c:pt>
                <c:pt idx="7">
                  <c:v>12.7</c:v>
                </c:pt>
                <c:pt idx="8">
                  <c:v>13.3</c:v>
                </c:pt>
                <c:pt idx="9">
                  <c:v>11.5</c:v>
                </c:pt>
                <c:pt idx="10">
                  <c:v>32.300000000000011</c:v>
                </c:pt>
                <c:pt idx="11">
                  <c:v>4.13</c:v>
                </c:pt>
                <c:pt idx="12">
                  <c:v>38.800000000000011</c:v>
                </c:pt>
                <c:pt idx="13">
                  <c:v>15.9</c:v>
                </c:pt>
                <c:pt idx="14">
                  <c:v>3.5</c:v>
                </c:pt>
                <c:pt idx="15">
                  <c:v>1.01</c:v>
                </c:pt>
                <c:pt idx="16">
                  <c:v>40.6</c:v>
                </c:pt>
                <c:pt idx="17">
                  <c:v>2.31</c:v>
                </c:pt>
                <c:pt idx="18">
                  <c:v>12.3</c:v>
                </c:pt>
                <c:pt idx="19">
                  <c:v>3.5</c:v>
                </c:pt>
                <c:pt idx="20">
                  <c:v>4.88</c:v>
                </c:pt>
                <c:pt idx="21">
                  <c:v>13.1</c:v>
                </c:pt>
                <c:pt idx="22">
                  <c:v>8.6999999999999994E-2</c:v>
                </c:pt>
                <c:pt idx="23">
                  <c:v>3.72</c:v>
                </c:pt>
                <c:pt idx="24">
                  <c:v>1</c:v>
                </c:pt>
                <c:pt idx="25">
                  <c:v>3.62</c:v>
                </c:pt>
                <c:pt idx="26">
                  <c:v>1.57</c:v>
                </c:pt>
                <c:pt idx="27">
                  <c:v>1</c:v>
                </c:pt>
                <c:pt idx="28">
                  <c:v>0.47799999999999998</c:v>
                </c:pt>
                <c:pt idx="29">
                  <c:v>11.7</c:v>
                </c:pt>
                <c:pt idx="30">
                  <c:v>1.91</c:v>
                </c:pt>
                <c:pt idx="31">
                  <c:v>1.47</c:v>
                </c:pt>
                <c:pt idx="32">
                  <c:v>2.39</c:v>
                </c:pt>
                <c:pt idx="33">
                  <c:v>8.23999999999999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E9-B44E-859B-BE2CE14B38C5}"/>
            </c:ext>
          </c:extLst>
        </c:ser>
        <c:ser>
          <c:idx val="1"/>
          <c:order val="1"/>
          <c:tx>
            <c:strRef>
              <c:f>Exposures!$A$4</c:f>
              <c:strCache>
                <c:ptCount val="1"/>
                <c:pt idx="0">
                  <c:v>Sig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Exposures!$B$2:$AI$2</c:f>
              <c:strCache>
                <c:ptCount val="34"/>
                <c:pt idx="0">
                  <c:v>A-10</c:v>
                </c:pt>
                <c:pt idx="1">
                  <c:v>A-1</c:v>
                </c:pt>
                <c:pt idx="2">
                  <c:v>A-2</c:v>
                </c:pt>
                <c:pt idx="3">
                  <c:v>A-3</c:v>
                </c:pt>
                <c:pt idx="4">
                  <c:v>A-4</c:v>
                </c:pt>
                <c:pt idx="5">
                  <c:v>A-5</c:v>
                </c:pt>
                <c:pt idx="6">
                  <c:v>A-7</c:v>
                </c:pt>
                <c:pt idx="7">
                  <c:v>A-9</c:v>
                </c:pt>
                <c:pt idx="8">
                  <c:v>B-1</c:v>
                </c:pt>
                <c:pt idx="9">
                  <c:v>B-2</c:v>
                </c:pt>
                <c:pt idx="10">
                  <c:v>B-3</c:v>
                </c:pt>
                <c:pt idx="11">
                  <c:v>B-4</c:v>
                </c:pt>
                <c:pt idx="12">
                  <c:v>B-5</c:v>
                </c:pt>
                <c:pt idx="13">
                  <c:v>B-6</c:v>
                </c:pt>
                <c:pt idx="14">
                  <c:v>B-7</c:v>
                </c:pt>
                <c:pt idx="15">
                  <c:v>C-10</c:v>
                </c:pt>
                <c:pt idx="16">
                  <c:v>C-1</c:v>
                </c:pt>
                <c:pt idx="17">
                  <c:v>C-2</c:v>
                </c:pt>
                <c:pt idx="18">
                  <c:v>C-3</c:v>
                </c:pt>
                <c:pt idx="19">
                  <c:v>C-4</c:v>
                </c:pt>
                <c:pt idx="20">
                  <c:v>C-5</c:v>
                </c:pt>
                <c:pt idx="21">
                  <c:v>C-6</c:v>
                </c:pt>
                <c:pt idx="22">
                  <c:v>C-7</c:v>
                </c:pt>
                <c:pt idx="23">
                  <c:v>C-8</c:v>
                </c:pt>
                <c:pt idx="24">
                  <c:v>C-9</c:v>
                </c:pt>
                <c:pt idx="25">
                  <c:v>D-10</c:v>
                </c:pt>
                <c:pt idx="26">
                  <c:v>D-1</c:v>
                </c:pt>
                <c:pt idx="27">
                  <c:v>D-2</c:v>
                </c:pt>
                <c:pt idx="28">
                  <c:v>D-3</c:v>
                </c:pt>
                <c:pt idx="29">
                  <c:v>D-4</c:v>
                </c:pt>
                <c:pt idx="30">
                  <c:v>D-5</c:v>
                </c:pt>
                <c:pt idx="31">
                  <c:v>D-7</c:v>
                </c:pt>
                <c:pt idx="32">
                  <c:v>D-8</c:v>
                </c:pt>
                <c:pt idx="33">
                  <c:v>D-9</c:v>
                </c:pt>
              </c:strCache>
            </c:strRef>
          </c:cat>
          <c:val>
            <c:numRef>
              <c:f>Exposures!$B$4:$AI$4</c:f>
              <c:numCache>
                <c:formatCode>0.00E+00</c:formatCode>
                <c:ptCount val="34"/>
                <c:pt idx="0">
                  <c:v>16.399999999999999</c:v>
                </c:pt>
                <c:pt idx="1">
                  <c:v>0.109</c:v>
                </c:pt>
                <c:pt idx="2">
                  <c:v>10.6</c:v>
                </c:pt>
                <c:pt idx="3">
                  <c:v>0.83699999999999997</c:v>
                </c:pt>
                <c:pt idx="4">
                  <c:v>0.71599999999999997</c:v>
                </c:pt>
                <c:pt idx="5">
                  <c:v>4.8099999999999996</c:v>
                </c:pt>
                <c:pt idx="6">
                  <c:v>6.43</c:v>
                </c:pt>
                <c:pt idx="7">
                  <c:v>3.25</c:v>
                </c:pt>
                <c:pt idx="8">
                  <c:v>0.71199999999999997</c:v>
                </c:pt>
                <c:pt idx="9">
                  <c:v>1.53</c:v>
                </c:pt>
                <c:pt idx="10">
                  <c:v>4.74</c:v>
                </c:pt>
                <c:pt idx="11">
                  <c:v>14.9</c:v>
                </c:pt>
                <c:pt idx="12">
                  <c:v>1.25</c:v>
                </c:pt>
                <c:pt idx="13">
                  <c:v>6.1800000000000001E-2</c:v>
                </c:pt>
                <c:pt idx="14">
                  <c:v>0.498</c:v>
                </c:pt>
                <c:pt idx="15">
                  <c:v>21</c:v>
                </c:pt>
                <c:pt idx="16">
                  <c:v>18.399999999999999</c:v>
                </c:pt>
                <c:pt idx="17">
                  <c:v>11.7</c:v>
                </c:pt>
                <c:pt idx="18">
                  <c:v>38.700000000000003</c:v>
                </c:pt>
                <c:pt idx="19">
                  <c:v>19.5</c:v>
                </c:pt>
                <c:pt idx="20">
                  <c:v>12.1</c:v>
                </c:pt>
                <c:pt idx="21">
                  <c:v>39.9</c:v>
                </c:pt>
                <c:pt idx="22">
                  <c:v>3.91</c:v>
                </c:pt>
                <c:pt idx="23">
                  <c:v>16.3</c:v>
                </c:pt>
                <c:pt idx="24">
                  <c:v>2.2400000000000001E-15</c:v>
                </c:pt>
                <c:pt idx="25">
                  <c:v>27.4</c:v>
                </c:pt>
                <c:pt idx="26">
                  <c:v>13.4</c:v>
                </c:pt>
                <c:pt idx="27">
                  <c:v>2.1900000000000001E-15</c:v>
                </c:pt>
                <c:pt idx="28">
                  <c:v>0.52200000000000002</c:v>
                </c:pt>
                <c:pt idx="29">
                  <c:v>17.3</c:v>
                </c:pt>
                <c:pt idx="30">
                  <c:v>4.09</c:v>
                </c:pt>
                <c:pt idx="31">
                  <c:v>0.53100000000000003</c:v>
                </c:pt>
                <c:pt idx="32">
                  <c:v>22.6</c:v>
                </c:pt>
                <c:pt idx="33">
                  <c:v>19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DE9-B44E-859B-BE2CE14B38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051559952"/>
        <c:axId val="-657530624"/>
      </c:barChart>
      <c:catAx>
        <c:axId val="-2051559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657530624"/>
        <c:crosses val="autoZero"/>
        <c:auto val="1"/>
        <c:lblAlgn val="ctr"/>
        <c:lblOffset val="100"/>
        <c:noMultiLvlLbl val="0"/>
      </c:catAx>
      <c:valAx>
        <c:axId val="-6575306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ja-JP"/>
          </a:p>
        </c:txPr>
        <c:crossAx val="-2051559952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9D31AA-7257-184A-906B-232E620BC29D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73F8C8-C5BE-2D4E-85C1-DD816EBF7A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7433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73F8C8-C5BE-2D4E-85C1-DD816EBF7AA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04811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BC4A6B-A8A3-391D-EB23-F560E64E11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CA9DE8E-AEC5-1F14-5C14-FD1DB4B259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4EFC0A8-27CB-C0C1-37FD-78E2149492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5200F-4257-6F4A-8478-52B220460737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C354DFF-4434-2A1C-60DD-0B811219CC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2CC1DF7-02C8-5A56-A0CF-EB2259A05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EF6F1-DF0F-4445-8509-5F7DE82EBF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1140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3A8265-6FC8-3FF8-E70D-7BFEC2D66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083F28C-F17D-0034-4EC5-8F42851793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7725F6-43B4-D61F-3EC4-C5289DCB7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5200F-4257-6F4A-8478-52B220460737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643DE7-B1EE-94FE-2A45-346A6D01D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1443405-702D-80AE-1DAF-2A09A6C9F7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EF6F1-DF0F-4445-8509-5F7DE82EBF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7899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3C7416A-5BCC-E1B4-E900-5ACE18192B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24AB87B-F919-9E50-1ACB-5F9176A495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856DDF5-E1BA-B7C4-C8D6-3213C7828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5200F-4257-6F4A-8478-52B220460737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8497F6-F9E7-7197-E1AD-3E577ED60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192188-7669-84A2-FA17-4E5643F9E3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EF6F1-DF0F-4445-8509-5F7DE82EBF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1534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56059EA-29B3-BD33-3EE2-B4CF1E0A2C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211F737-3074-3665-1C0D-9B0DDE9C19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C604BC-C1BD-D22F-0ED9-FF9B2BB0B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5200F-4257-6F4A-8478-52B220460737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E5D280-6CFB-57B6-D8E1-09F991CC3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78B559F-BB2B-6F93-A0B8-BEED4A2BE1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EF6F1-DF0F-4445-8509-5F7DE82EBF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890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8922B0-00D9-E63B-9FD8-BB9B2031BF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2E0F523-13F0-654E-7307-E420F068DC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C8634B-02FF-ADA4-E4C8-8F9FC34F5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5200F-4257-6F4A-8478-52B220460737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5FE9B8-D64E-DE9E-5FAC-CE7FD9F0D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78A76F-F265-6DAE-C623-3644CC15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EF6F1-DF0F-4445-8509-5F7DE82EBF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838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FAA71F-21D9-A37F-8D1B-3543B7C607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76A99C9-43A9-A720-120B-55DA0645B1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C99332A-0AE9-C449-95E3-948170E878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60E06F9-3DE6-ECEA-DB4C-CB7AB5AA9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5200F-4257-6F4A-8478-52B220460737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F06E59D-795E-2AD1-F632-BC6E8C830A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10A7CE6-3582-FED3-3B94-F81A76243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EF6F1-DF0F-4445-8509-5F7DE82EBF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6729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547D28-4FC0-DCB1-477B-BE03A309C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0AF2FEB-8C6C-6CAE-09FB-306CFD40FC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B9DDD3F-4A84-9B9C-ECB5-537CE7A42B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76FC0A7-73AA-3208-5EB6-9C8DFF577E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27EAF37-9F88-B776-47F8-CAAD3FD1D1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732627F-7378-B054-A411-46B8520E3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5200F-4257-6F4A-8478-52B220460737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5D27C13-4C57-28AF-17D9-7FD5C128A1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AF3438B-6D11-5B90-AF99-D60F33E472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EF6F1-DF0F-4445-8509-5F7DE82EBF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0208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97DA41-5ECA-A0C1-AB27-F3A66D1B8E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6D0758F-CE34-571F-65E5-8F510AC36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5200F-4257-6F4A-8478-52B220460737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DA0578C-DA0A-973D-C421-0BE06E932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8C953D3-BC99-E776-F95D-9083CF7708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EF6F1-DF0F-4445-8509-5F7DE82EBF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828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B971D25-AC4E-DAD5-A90A-F537CFF7B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5200F-4257-6F4A-8478-52B220460737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1B03788-006C-B095-779A-F3476CDDD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4626319-A4C6-8A00-9BAE-55B339D92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EF6F1-DF0F-4445-8509-5F7DE82EBF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6456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497F8C2-2A06-C72D-0C94-09CD7F2E32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DB39E96-364D-1740-DED4-3040DA8891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614E463-D781-D67C-5064-BBE899D314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7581C7B-8B1C-622A-780F-5C755245F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5200F-4257-6F4A-8478-52B220460737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F20FD62-2557-3D23-3425-67D4F9B62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EDCEFC8-BEFB-C27F-45CB-B75BC6FBF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EF6F1-DF0F-4445-8509-5F7DE82EBF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6971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2FDEC4-FE21-3541-0732-5237D9F5B4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4A4662E-F399-E6DE-ED4D-06130B232B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3C8074B-D504-28F9-B492-C4E8F5CA8B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B157593-FB17-BBD6-7A74-1E824E857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5200F-4257-6F4A-8478-52B220460737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FCD0BC6-0510-98F1-37CD-1A43DD813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A6EDF82-3469-3176-8410-F362B0FCA2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EF6F1-DF0F-4445-8509-5F7DE82EBF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69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39B644B-20CF-9F9B-0BA9-D1931436C6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323C20C-4917-D473-E6E4-82C61B026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D9368B6-4949-8A8B-7D0F-E2E8412141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05200F-4257-6F4A-8478-52B220460737}" type="datetimeFigureOut">
              <a:rPr kumimoji="1" lang="ja-JP" altLang="en-US" smtClean="0"/>
              <a:t>2024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9F27DC6-EA0D-82EF-D082-AFD0A1951B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86D748-B962-AAD3-0D9A-ED64339B02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00EF6F1-DF0F-4445-8509-5F7DE82EBF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7846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4E1F79E3-0659-56F6-D873-51C5197B55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918476"/>
              </p:ext>
            </p:extLst>
          </p:nvPr>
        </p:nvGraphicFramePr>
        <p:xfrm>
          <a:off x="1708902" y="3653396"/>
          <a:ext cx="8922967" cy="30905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57836159-10F3-09D3-9385-DDE503AA9E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8446120"/>
              </p:ext>
            </p:extLst>
          </p:nvPr>
        </p:nvGraphicFramePr>
        <p:xfrm>
          <a:off x="1760505" y="555866"/>
          <a:ext cx="8829760" cy="32600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B516112-319A-A8A1-C7F5-5460D036A500}"/>
              </a:ext>
            </a:extLst>
          </p:cNvPr>
          <p:cNvSpPr txBox="1"/>
          <p:nvPr/>
        </p:nvSpPr>
        <p:spPr>
          <a:xfrm>
            <a:off x="557048" y="496371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igure S1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54392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641569474"/>
              </p:ext>
            </p:extLst>
          </p:nvPr>
        </p:nvGraphicFramePr>
        <p:xfrm>
          <a:off x="706057" y="1552356"/>
          <a:ext cx="10694043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8" name="図 7">
            <a:extLst>
              <a:ext uri="{FF2B5EF4-FFF2-40B4-BE49-F238E27FC236}">
                <a16:creationId xmlns:a16="http://schemas.microsoft.com/office/drawing/2014/main" id="{75C8771E-3CCA-E7BF-2721-5DA98D25BE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90233" y="1202440"/>
            <a:ext cx="253078" cy="230071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C7D5DBBF-5373-655F-7192-5B0C9B6B561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69237" y="820535"/>
            <a:ext cx="276085" cy="253078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C7B556E-3C70-BE47-D33B-043437D5BA55}"/>
              </a:ext>
            </a:extLst>
          </p:cNvPr>
          <p:cNvSpPr txBox="1"/>
          <p:nvPr/>
        </p:nvSpPr>
        <p:spPr>
          <a:xfrm>
            <a:off x="8443311" y="809180"/>
            <a:ext cx="1289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ignature B1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F0410BD-DCFF-5DA3-081B-F355714FE980}"/>
              </a:ext>
            </a:extLst>
          </p:cNvPr>
          <p:cNvSpPr txBox="1"/>
          <p:nvPr/>
        </p:nvSpPr>
        <p:spPr>
          <a:xfrm>
            <a:off x="8443311" y="1184656"/>
            <a:ext cx="1289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ignature B2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F41D2988-E9F7-8F92-0142-90263F44E846}"/>
              </a:ext>
            </a:extLst>
          </p:cNvPr>
          <p:cNvGrpSpPr/>
          <p:nvPr/>
        </p:nvGrpSpPr>
        <p:grpSpPr>
          <a:xfrm>
            <a:off x="1318661" y="5295606"/>
            <a:ext cx="9894771" cy="279128"/>
            <a:chOff x="1318661" y="5295606"/>
            <a:chExt cx="9894771" cy="279128"/>
          </a:xfrm>
        </p:grpSpPr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37251C79-0FD8-E432-1FB2-6F537417BC4C}"/>
                </a:ext>
              </a:extLst>
            </p:cNvPr>
            <p:cNvSpPr/>
            <p:nvPr/>
          </p:nvSpPr>
          <p:spPr>
            <a:xfrm>
              <a:off x="1318661" y="5303526"/>
              <a:ext cx="2311507" cy="269508"/>
            </a:xfrm>
            <a:prstGeom prst="rect">
              <a:avLst/>
            </a:prstGeom>
            <a:solidFill>
              <a:schemeClr val="tx2">
                <a:lumMod val="10000"/>
                <a:lumOff val="9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-TCA</a:t>
              </a:r>
              <a:endParaRPr kumimoji="1" lang="ja-JP" altLang="en-US" sz="16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F3CDC283-047C-2179-7BEB-89CC036E93E2}"/>
                </a:ext>
              </a:extLst>
            </p:cNvPr>
            <p:cNvSpPr/>
            <p:nvPr/>
          </p:nvSpPr>
          <p:spPr>
            <a:xfrm>
              <a:off x="3630168" y="5303527"/>
              <a:ext cx="2048737" cy="269508"/>
            </a:xfrm>
            <a:prstGeom prst="rect">
              <a:avLst/>
            </a:prstGeom>
            <a:solidFill>
              <a:schemeClr val="tx2">
                <a:lumMod val="25000"/>
                <a:lumOff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-TDCA</a:t>
              </a:r>
              <a:endParaRPr kumimoji="1" lang="ja-JP" altLang="en-US" sz="16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0D662E3A-514E-078E-F082-A1D1811B9684}"/>
                </a:ext>
              </a:extLst>
            </p:cNvPr>
            <p:cNvSpPr/>
            <p:nvPr/>
          </p:nvSpPr>
          <p:spPr>
            <a:xfrm>
              <a:off x="5678905" y="5305226"/>
              <a:ext cx="2935706" cy="269508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-GCA</a:t>
              </a:r>
              <a:endParaRPr kumimoji="1" lang="ja-JP" altLang="en-US" sz="16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80BE00C8-5529-7686-AB04-D2C493F45B44}"/>
                </a:ext>
              </a:extLst>
            </p:cNvPr>
            <p:cNvSpPr/>
            <p:nvPr/>
          </p:nvSpPr>
          <p:spPr>
            <a:xfrm>
              <a:off x="8614611" y="5295606"/>
              <a:ext cx="2598821" cy="269508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-GDCA</a:t>
              </a:r>
              <a:endParaRPr kumimoji="1" lang="ja-JP" altLang="en-US" sz="16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B1E0E8AE-392C-4DC0-31C0-138D0F3586ED}"/>
              </a:ext>
            </a:extLst>
          </p:cNvPr>
          <p:cNvSpPr/>
          <p:nvPr/>
        </p:nvSpPr>
        <p:spPr>
          <a:xfrm>
            <a:off x="5678905" y="5573034"/>
            <a:ext cx="885524" cy="3306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9D958F7E-0941-0EDD-27F4-D5DCA2DA052A}"/>
              </a:ext>
            </a:extLst>
          </p:cNvPr>
          <p:cNvCxnSpPr>
            <a:endCxn id="17" idx="1"/>
          </p:cNvCxnSpPr>
          <p:nvPr/>
        </p:nvCxnSpPr>
        <p:spPr>
          <a:xfrm>
            <a:off x="1318661" y="5738364"/>
            <a:ext cx="4360244" cy="0"/>
          </a:xfrm>
          <a:prstGeom prst="line">
            <a:avLst/>
          </a:prstGeom>
          <a:ln w="508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9435D1AE-D8EF-AD42-BC5C-385F7798EE69}"/>
              </a:ext>
            </a:extLst>
          </p:cNvPr>
          <p:cNvCxnSpPr>
            <a:cxnSpLocks/>
          </p:cNvCxnSpPr>
          <p:nvPr/>
        </p:nvCxnSpPr>
        <p:spPr>
          <a:xfrm>
            <a:off x="5698181" y="5738364"/>
            <a:ext cx="5515251" cy="0"/>
          </a:xfrm>
          <a:prstGeom prst="line">
            <a:avLst/>
          </a:prstGeom>
          <a:ln w="50800">
            <a:solidFill>
              <a:schemeClr val="accent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1F09974-E2AD-C895-A296-D1B03E210C1F}"/>
              </a:ext>
            </a:extLst>
          </p:cNvPr>
          <p:cNvSpPr txBox="1"/>
          <p:nvPr/>
        </p:nvSpPr>
        <p:spPr>
          <a:xfrm>
            <a:off x="1631973" y="5817082"/>
            <a:ext cx="38587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-nitroso taurine bile acid conjugates</a:t>
            </a:r>
            <a:endParaRPr kumimoji="1"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970ECDE-F78D-93A9-199F-553ECEFCC3B4}"/>
              </a:ext>
            </a:extLst>
          </p:cNvPr>
          <p:cNvSpPr txBox="1"/>
          <p:nvPr/>
        </p:nvSpPr>
        <p:spPr>
          <a:xfrm>
            <a:off x="6387397" y="5816232"/>
            <a:ext cx="38811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-nitroso glycine bile acid conjugates</a:t>
            </a:r>
            <a:endParaRPr kumimoji="1"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9EB019E-1DB0-E511-B1F1-341A9941147E}"/>
              </a:ext>
            </a:extLst>
          </p:cNvPr>
          <p:cNvSpPr txBox="1"/>
          <p:nvPr/>
        </p:nvSpPr>
        <p:spPr>
          <a:xfrm>
            <a:off x="557048" y="496371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igure S2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2917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55F51C4-64B7-C5E4-408D-2BCE77406C9B}"/>
              </a:ext>
            </a:extLst>
          </p:cNvPr>
          <p:cNvSpPr txBox="1"/>
          <p:nvPr/>
        </p:nvSpPr>
        <p:spPr>
          <a:xfrm>
            <a:off x="557048" y="496371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igure S3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13ADD2A4-4A19-20AD-9740-112A83FBB7FC}"/>
              </a:ext>
            </a:extLst>
          </p:cNvPr>
          <p:cNvGrpSpPr/>
          <p:nvPr/>
        </p:nvGrpSpPr>
        <p:grpSpPr>
          <a:xfrm>
            <a:off x="4143032" y="1828931"/>
            <a:ext cx="3062209" cy="3412175"/>
            <a:chOff x="4143032" y="1828931"/>
            <a:chExt cx="3062209" cy="3412175"/>
          </a:xfrm>
        </p:grpSpPr>
        <p:pic>
          <p:nvPicPr>
            <p:cNvPr id="2" name="図 1" descr="グラフ, 棒グラフ&#10;&#10;自動的に生成された説明">
              <a:extLst>
                <a:ext uri="{FF2B5EF4-FFF2-40B4-BE49-F238E27FC236}">
                  <a16:creationId xmlns:a16="http://schemas.microsoft.com/office/drawing/2014/main" id="{3ECAAA5B-EEEB-6F34-D665-43EE5834AFB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43032" y="1828931"/>
              <a:ext cx="3062209" cy="3412175"/>
            </a:xfrm>
            <a:prstGeom prst="rect">
              <a:avLst/>
            </a:prstGeom>
          </p:spPr>
        </p:pic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1EF35217-B566-BB99-0C0B-27305EF311AA}"/>
                </a:ext>
              </a:extLst>
            </p:cNvPr>
            <p:cNvSpPr/>
            <p:nvPr/>
          </p:nvSpPr>
          <p:spPr>
            <a:xfrm>
              <a:off x="5544273" y="2187615"/>
              <a:ext cx="129863" cy="2083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6F3DE20E-97EB-39F7-2ECB-B712347BE165}"/>
                </a:ext>
              </a:extLst>
            </p:cNvPr>
            <p:cNvSpPr/>
            <p:nvPr/>
          </p:nvSpPr>
          <p:spPr>
            <a:xfrm>
              <a:off x="5847147" y="2201115"/>
              <a:ext cx="129863" cy="2083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dirty="0"/>
                <a:t>___</a:t>
              </a:r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576206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88</TotalTime>
  <Words>30</Words>
  <Application>Microsoft Macintosh PowerPoint</Application>
  <PresentationFormat>ワイド画面</PresentationFormat>
  <Paragraphs>15</Paragraphs>
  <Slides>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トツカユカリ</dc:creator>
  <cp:lastModifiedBy>戸塚（内田）　ゆ加里</cp:lastModifiedBy>
  <cp:revision>36</cp:revision>
  <dcterms:created xsi:type="dcterms:W3CDTF">2024-07-08T03:48:31Z</dcterms:created>
  <dcterms:modified xsi:type="dcterms:W3CDTF">2024-10-09T02:40:19Z</dcterms:modified>
</cp:coreProperties>
</file>